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507" autoAdjust="0"/>
  </p:normalViewPr>
  <p:slideViewPr>
    <p:cSldViewPr snapToObjects="1">
      <p:cViewPr varScale="1">
        <p:scale>
          <a:sx n="91" d="100"/>
          <a:sy n="91" d="100"/>
        </p:scale>
        <p:origin x="-61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30" y="18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F5B9A4-A5EB-480E-B8B8-4D7905D02012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E102C1-3D0C-4A46-AD49-1294C2451D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5431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i="1" dirty="0" smtClean="0"/>
              <a:t>Supplementary </a:t>
            </a:r>
            <a:r>
              <a:rPr lang="en-GB" i="1" smtClean="0"/>
              <a:t>figure </a:t>
            </a:r>
            <a:r>
              <a:rPr lang="en-GB" i="1" smtClean="0"/>
              <a:t>4: </a:t>
            </a:r>
            <a:r>
              <a:rPr lang="en-GB" i="0" dirty="0" smtClean="0"/>
              <a:t>Homoserine</a:t>
            </a:r>
            <a:r>
              <a:rPr lang="en-GB" i="0" baseline="0" dirty="0" smtClean="0"/>
              <a:t> treatment reduces </a:t>
            </a:r>
            <a:r>
              <a:rPr lang="en-GB" i="1" baseline="0" dirty="0" smtClean="0"/>
              <a:t>F. culmorum </a:t>
            </a:r>
            <a:r>
              <a:rPr lang="en-GB" i="0" baseline="0" dirty="0" smtClean="0"/>
              <a:t>growth in point inoculated </a:t>
            </a:r>
            <a:r>
              <a:rPr lang="en-GB" i="1" baseline="0" dirty="0" smtClean="0"/>
              <a:t>eds1-2 </a:t>
            </a:r>
            <a:r>
              <a:rPr lang="en-GB" i="0" baseline="0" dirty="0" smtClean="0"/>
              <a:t>siliques. Tip-wounded </a:t>
            </a:r>
            <a:r>
              <a:rPr lang="en-GB" i="1" baseline="0" dirty="0" smtClean="0"/>
              <a:t>eds1-2 </a:t>
            </a:r>
            <a:r>
              <a:rPr lang="en-GB" i="0" baseline="0" dirty="0" smtClean="0"/>
              <a:t>siliques were treated with 10mM L-homoserine (LHS), D-homoserine (DHS) or sterile water coincident with </a:t>
            </a:r>
            <a:r>
              <a:rPr lang="en-GB" i="1" baseline="0" dirty="0" smtClean="0"/>
              <a:t>F. culmorum </a:t>
            </a:r>
            <a:r>
              <a:rPr lang="en-GB" i="0" baseline="0" dirty="0" smtClean="0"/>
              <a:t>inoculation. Amino acid/water treatment was repeated for 5dpi. Images show opened silique sections at 8dpi. Tissue necrosis and fungal growth is evident in the pericarp (P) and seed (S) of water and D-homoserine (DHS) treated siliques. L-homoserine (LHS) treated siliques have predominantly uninfected pericarps, but some externally uninfected LHS treated siliques revealed, when opened, the presence of fungal colonisation within the silique (far right).</a:t>
            </a:r>
            <a:endParaRPr lang="en-GB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E102C1-3D0C-4A46-AD49-1294C2451DA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65853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941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876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146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098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0865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245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907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77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575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643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1154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AD447-369C-4904-B761-0E3E8C1B3DA4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01984-CA54-401E-BAEB-C0F06728B2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8621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7632" y="332657"/>
            <a:ext cx="2405292" cy="40243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440" y="332656"/>
            <a:ext cx="1838912" cy="402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0581" y="332657"/>
            <a:ext cx="1819851" cy="40243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1369" y="332657"/>
            <a:ext cx="1850893" cy="40243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684430" y="4028040"/>
            <a:ext cx="1365245" cy="544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Water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38046" y="4036582"/>
            <a:ext cx="972232" cy="544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DHS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83896" y="4036583"/>
            <a:ext cx="1158062" cy="544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LHS</a:t>
            </a:r>
            <a:endParaRPr lang="en-GB" b="1" dirty="0">
              <a:solidFill>
                <a:schemeClr val="bg1"/>
              </a:solidFill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2518352" y="332656"/>
            <a:ext cx="0" cy="402431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783896" y="332656"/>
            <a:ext cx="0" cy="402431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124162" y="1332635"/>
            <a:ext cx="21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P</a:t>
            </a:r>
            <a:endParaRPr lang="en-GB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999920" y="2988819"/>
            <a:ext cx="21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P</a:t>
            </a:r>
            <a:endParaRPr lang="en-GB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339192" y="1517301"/>
            <a:ext cx="21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500491" y="2986711"/>
            <a:ext cx="21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627028" y="1478476"/>
            <a:ext cx="219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S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4709462"/>
            <a:ext cx="91440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i="1" dirty="0"/>
              <a:t>Supplementary figure </a:t>
            </a:r>
            <a:r>
              <a:rPr lang="en-GB" sz="1600" i="1" dirty="0" smtClean="0"/>
              <a:t>4: </a:t>
            </a:r>
            <a:r>
              <a:rPr lang="en-GB" sz="1600" dirty="0"/>
              <a:t>Homoserine treatment reduces </a:t>
            </a:r>
            <a:r>
              <a:rPr lang="en-GB" sz="1600" i="1" dirty="0"/>
              <a:t>F. culmorum </a:t>
            </a:r>
            <a:r>
              <a:rPr lang="en-GB" sz="1600" dirty="0"/>
              <a:t>growth in point inoculated </a:t>
            </a:r>
            <a:r>
              <a:rPr lang="en-GB" sz="1600" i="1" dirty="0"/>
              <a:t>eds1-2 </a:t>
            </a:r>
            <a:r>
              <a:rPr lang="en-GB" sz="1600" dirty="0"/>
              <a:t>siliques. Tip-wounded </a:t>
            </a:r>
            <a:r>
              <a:rPr lang="en-GB" sz="1600" i="1" dirty="0"/>
              <a:t>eds1-2 </a:t>
            </a:r>
            <a:r>
              <a:rPr lang="en-GB" sz="1600" dirty="0"/>
              <a:t>siliques were treated with 10mM L-homoserine (LHS), D-homoserine (DHS) or sterile water coincident with </a:t>
            </a:r>
            <a:r>
              <a:rPr lang="en-GB" sz="1600" i="1" dirty="0"/>
              <a:t>F. culmorum </a:t>
            </a:r>
            <a:r>
              <a:rPr lang="en-GB" sz="1600" dirty="0"/>
              <a:t>inoculation. Amino acid/water treatment was repeated for 5dpi. Images show opened silique sections at 8dpi. Tissue necrosis and fungal growth is evident in the pericarp (P) and seed (S) of water and D-homoserine (DHS) treated siliques. L-homoserine (LHS) treated siliques have predominantly uninfected pericarps, but some externally uninfected LHS treated siliques revealed, when opened, the presence of fungal colonisation within the silique (far right).</a:t>
            </a:r>
            <a:endParaRPr lang="en-GB" sz="1600" i="1" dirty="0"/>
          </a:p>
        </p:txBody>
      </p:sp>
    </p:spTree>
    <p:extLst>
      <p:ext uri="{BB962C8B-B14F-4D97-AF65-F5344CB8AC3E}">
        <p14:creationId xmlns:p14="http://schemas.microsoft.com/office/powerpoint/2010/main" val="3130317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51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6</cp:revision>
  <dcterms:created xsi:type="dcterms:W3CDTF">2014-03-17T17:28:42Z</dcterms:created>
  <dcterms:modified xsi:type="dcterms:W3CDTF">2014-03-28T22:26:26Z</dcterms:modified>
</cp:coreProperties>
</file>